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61" autoAdjust="0"/>
    <p:restoredTop sz="94660"/>
  </p:normalViewPr>
  <p:slideViewPr>
    <p:cSldViewPr snapToGrid="0">
      <p:cViewPr varScale="1">
        <p:scale>
          <a:sx n="45" d="100"/>
          <a:sy n="45" d="100"/>
        </p:scale>
        <p:origin x="24" y="9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C5B659-9750-4009-85E8-97052E46EEC4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EE4FD7-6124-4C12-A484-1FB7E5DB01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88474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C5B659-9750-4009-85E8-97052E46EEC4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EE4FD7-6124-4C12-A484-1FB7E5DB01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56287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C5B659-9750-4009-85E8-97052E46EEC4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EE4FD7-6124-4C12-A484-1FB7E5DB01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27121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C5B659-9750-4009-85E8-97052E46EEC4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EE4FD7-6124-4C12-A484-1FB7E5DB01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12627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C5B659-9750-4009-85E8-97052E46EEC4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EE4FD7-6124-4C12-A484-1FB7E5DB01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42373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C5B659-9750-4009-85E8-97052E46EEC4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EE4FD7-6124-4C12-A484-1FB7E5DB01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58380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C5B659-9750-4009-85E8-97052E46EEC4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EE4FD7-6124-4C12-A484-1FB7E5DB01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94838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C5B659-9750-4009-85E8-97052E46EEC4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EE4FD7-6124-4C12-A484-1FB7E5DB01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85655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C5B659-9750-4009-85E8-97052E46EEC4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EE4FD7-6124-4C12-A484-1FB7E5DB01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78681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C5B659-9750-4009-85E8-97052E46EEC4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EE4FD7-6124-4C12-A484-1FB7E5DB01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16993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C5B659-9750-4009-85E8-97052E46EEC4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EE4FD7-6124-4C12-A484-1FB7E5DB01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4082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C5B659-9750-4009-85E8-97052E46EEC4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EE4FD7-6124-4C12-A484-1FB7E5DB01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21721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64632" y="721895"/>
            <a:ext cx="8621879" cy="4907380"/>
          </a:xfrm>
          <a:prstGeom prst="rect">
            <a:avLst/>
          </a:prstGeom>
          <a:noFill/>
          <a:ln>
            <a:noFill/>
          </a:ln>
        </p:spPr>
      </p:pic>
      <p:sp>
        <p:nvSpPr>
          <p:cNvPr id="2" name="Rectangle 1"/>
          <p:cNvSpPr>
            <a:spLocks noChangeArrowheads="1"/>
          </p:cNvSpPr>
          <p:nvPr/>
        </p:nvSpPr>
        <p:spPr bwMode="auto">
          <a:xfrm>
            <a:off x="1236133" y="5825067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Figure S22.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Correlation between β-</a:t>
            </a:r>
            <a:r>
              <a:rPr kumimoji="0" lang="en-US" altLang="en-US" sz="1200" b="0" i="0" u="sng" strike="noStrike" cap="none" normalizeH="0" baseline="0" smtClean="0">
                <a:ln>
                  <a:noFill/>
                </a:ln>
                <a:solidFill>
                  <a:srgbClr val="008080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haematin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inhibition activity (BIHA</a:t>
            </a:r>
            <a:r>
              <a:rPr kumimoji="0" lang="en-US" altLang="en-US" sz="1200" b="0" i="0" u="none" strike="noStrike" cap="none" normalizeH="0" baseline="-3000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50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, µM) and </a:t>
            </a:r>
            <a:r>
              <a:rPr kumimoji="0" lang="en-US" altLang="en-US" sz="1200" b="0" i="0" u="sng" strike="noStrike" cap="none" normalizeH="0" baseline="0" smtClean="0">
                <a:ln>
                  <a:noFill/>
                </a:ln>
                <a:solidFill>
                  <a:srgbClr val="008080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anti-malarial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activity (IC</a:t>
            </a:r>
            <a:r>
              <a:rPr kumimoji="0" lang="en-US" altLang="en-US" sz="1200" b="0" i="0" u="none" strike="noStrike" cap="none" normalizeH="0" baseline="-3000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50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­, nM) for biquinolines against sensitive strain W2 and D6</a:t>
            </a: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rPr>
              <a:t> 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801936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9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MS Mincho</vt:lpstr>
      <vt:lpstr>Times New Roman</vt:lpstr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goc Nguyen</dc:creator>
  <cp:lastModifiedBy>Ngoc Nguyen</cp:lastModifiedBy>
  <cp:revision>2</cp:revision>
  <dcterms:created xsi:type="dcterms:W3CDTF">2020-07-03T16:16:51Z</dcterms:created>
  <dcterms:modified xsi:type="dcterms:W3CDTF">2020-08-04T16:35:45Z</dcterms:modified>
</cp:coreProperties>
</file>